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8C495-47C3-4B63-8E7C-3F5864EE04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1E9FD0-1E43-4C15-849B-CA4B08E0CC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FB51C-BA52-425D-98A9-C5A3801F83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4B628B-99BA-4F8A-B49C-4B21216C47C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92CB0-E30F-4812-9731-016B076B38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6F90D4-6921-449F-895A-395EC79D95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FF8A08-10D2-4034-8934-991C4258CC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BFAA2D-0638-403A-A0FB-586A5B1941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5F83F-AAC0-4210-A65D-D79B164BAA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77834-6103-4A97-A9D1-C0DB157DA1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72D02-3A62-4C7E-9F23-680A0B6F1E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1B34B-7163-4767-B01C-667A4A988C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07846AB-E7B7-4DAF-BCB3-5971E42E1FC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44454" t="70900" r="40628" b="5663"/>
          <a:stretch/>
        </p:blipFill>
        <p:spPr>
          <a:xfrm>
            <a:off x="7674120" y="2422440"/>
            <a:ext cx="985680" cy="1238400"/>
          </a:xfrm>
          <a:prstGeom prst="rect">
            <a:avLst/>
          </a:prstGeom>
          <a:ln w="0">
            <a:noFill/>
          </a:ln>
        </p:spPr>
      </p:pic>
      <p:sp>
        <p:nvSpPr>
          <p:cNvPr id="42" name="Text Box 3"/>
          <p:cNvSpPr/>
          <p:nvPr/>
        </p:nvSpPr>
        <p:spPr>
          <a:xfrm>
            <a:off x="7774200" y="3705120"/>
            <a:ext cx="846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242C&gt;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4" descr=""/>
          <p:cNvPicPr/>
          <p:nvPr/>
        </p:nvPicPr>
        <p:blipFill>
          <a:blip r:embed="rId2"/>
          <a:srcRect l="44519" t="73683" r="42060" b="5404"/>
          <a:stretch/>
        </p:blipFill>
        <p:spPr>
          <a:xfrm>
            <a:off x="1968480" y="4900680"/>
            <a:ext cx="987480" cy="1230120"/>
          </a:xfrm>
          <a:prstGeom prst="rect">
            <a:avLst/>
          </a:prstGeom>
          <a:ln w="0">
            <a:noFill/>
          </a:ln>
        </p:spPr>
      </p:pic>
      <p:sp>
        <p:nvSpPr>
          <p:cNvPr id="44" name="Text Box 5"/>
          <p:cNvSpPr/>
          <p:nvPr/>
        </p:nvSpPr>
        <p:spPr>
          <a:xfrm>
            <a:off x="1943640" y="6143760"/>
            <a:ext cx="1159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95_96delG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Picture 6" descr=""/>
          <p:cNvPicPr/>
          <p:nvPr/>
        </p:nvPicPr>
        <p:blipFill>
          <a:blip r:embed="rId3"/>
          <a:srcRect l="35535" t="71535" r="49482" b="5615"/>
          <a:stretch/>
        </p:blipFill>
        <p:spPr>
          <a:xfrm>
            <a:off x="3174840" y="1001880"/>
            <a:ext cx="987480" cy="1204920"/>
          </a:xfrm>
          <a:prstGeom prst="rect">
            <a:avLst/>
          </a:prstGeom>
          <a:ln w="0">
            <a:noFill/>
          </a:ln>
        </p:spPr>
      </p:pic>
      <p:sp>
        <p:nvSpPr>
          <p:cNvPr id="46" name="Text Box 7"/>
          <p:cNvSpPr/>
          <p:nvPr/>
        </p:nvSpPr>
        <p:spPr>
          <a:xfrm>
            <a:off x="3257640" y="2217600"/>
            <a:ext cx="85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176A&gt;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8" descr=""/>
          <p:cNvPicPr/>
          <p:nvPr/>
        </p:nvPicPr>
        <p:blipFill>
          <a:blip r:embed="rId4"/>
          <a:srcRect l="45236" t="42693" r="39456" b="33936"/>
          <a:stretch/>
        </p:blipFill>
        <p:spPr>
          <a:xfrm>
            <a:off x="1843200" y="1538280"/>
            <a:ext cx="987480" cy="1204920"/>
          </a:xfrm>
          <a:prstGeom prst="rect">
            <a:avLst/>
          </a:prstGeom>
          <a:ln w="0">
            <a:noFill/>
          </a:ln>
        </p:spPr>
      </p:pic>
      <p:sp>
        <p:nvSpPr>
          <p:cNvPr id="48" name="Text Box 9"/>
          <p:cNvSpPr/>
          <p:nvPr/>
        </p:nvSpPr>
        <p:spPr>
          <a:xfrm>
            <a:off x="1976400" y="275580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126A&gt;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10" descr=""/>
          <p:cNvPicPr/>
          <p:nvPr/>
        </p:nvPicPr>
        <p:blipFill>
          <a:blip r:embed="rId5"/>
          <a:srcRect l="39284" t="42501" r="45328" b="34036"/>
          <a:stretch/>
        </p:blipFill>
        <p:spPr>
          <a:xfrm>
            <a:off x="741240" y="4154400"/>
            <a:ext cx="987480" cy="1204920"/>
          </a:xfrm>
          <a:prstGeom prst="rect">
            <a:avLst/>
          </a:prstGeom>
          <a:ln w="0">
            <a:noFill/>
          </a:ln>
        </p:spPr>
      </p:pic>
      <p:sp>
        <p:nvSpPr>
          <p:cNvPr id="50" name="Text Box 11"/>
          <p:cNvSpPr/>
          <p:nvPr/>
        </p:nvSpPr>
        <p:spPr>
          <a:xfrm>
            <a:off x="846000" y="5383080"/>
            <a:ext cx="77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83T&gt;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2" descr=""/>
          <p:cNvPicPr/>
          <p:nvPr/>
        </p:nvPicPr>
        <p:blipFill>
          <a:blip r:embed="rId6"/>
          <a:srcRect l="42491" t="72122" r="42877" b="5810"/>
          <a:stretch/>
        </p:blipFill>
        <p:spPr>
          <a:xfrm>
            <a:off x="7196040" y="749160"/>
            <a:ext cx="986040" cy="1189080"/>
          </a:xfrm>
          <a:prstGeom prst="rect">
            <a:avLst/>
          </a:prstGeom>
          <a:ln w="0">
            <a:noFill/>
          </a:ln>
        </p:spPr>
      </p:pic>
      <p:sp>
        <p:nvSpPr>
          <p:cNvPr id="52" name="Text Box 13"/>
          <p:cNvSpPr/>
          <p:nvPr/>
        </p:nvSpPr>
        <p:spPr>
          <a:xfrm>
            <a:off x="7280280" y="1982880"/>
            <a:ext cx="872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287C&gt;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4" descr=""/>
          <p:cNvPicPr/>
          <p:nvPr/>
        </p:nvPicPr>
        <p:blipFill>
          <a:blip r:embed="rId7"/>
          <a:srcRect l="44168" t="42416" r="40743" b="34147"/>
          <a:stretch/>
        </p:blipFill>
        <p:spPr>
          <a:xfrm>
            <a:off x="3409920" y="5299200"/>
            <a:ext cx="982800" cy="1220760"/>
          </a:xfrm>
          <a:prstGeom prst="rect">
            <a:avLst/>
          </a:prstGeom>
          <a:ln w="0">
            <a:noFill/>
          </a:ln>
        </p:spPr>
      </p:pic>
      <p:sp>
        <p:nvSpPr>
          <p:cNvPr id="54" name="Text Box 15"/>
          <p:cNvSpPr/>
          <p:nvPr/>
        </p:nvSpPr>
        <p:spPr>
          <a:xfrm>
            <a:off x="3467880" y="6537240"/>
            <a:ext cx="855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107G&gt;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16" descr=""/>
          <p:cNvPicPr/>
          <p:nvPr/>
        </p:nvPicPr>
        <p:blipFill>
          <a:blip r:embed="rId8"/>
          <a:srcRect l="42957" t="42386" r="41747" b="34051"/>
          <a:stretch/>
        </p:blipFill>
        <p:spPr>
          <a:xfrm>
            <a:off x="4549680" y="1687680"/>
            <a:ext cx="984240" cy="1212840"/>
          </a:xfrm>
          <a:prstGeom prst="rect">
            <a:avLst/>
          </a:prstGeom>
          <a:ln w="0">
            <a:noFill/>
          </a:ln>
        </p:spPr>
      </p:pic>
      <p:sp>
        <p:nvSpPr>
          <p:cNvPr id="56" name="Text Box 17"/>
          <p:cNvSpPr/>
          <p:nvPr/>
        </p:nvSpPr>
        <p:spPr>
          <a:xfrm>
            <a:off x="4587840" y="292752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182G&gt;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18" descr=""/>
          <p:cNvPicPr/>
          <p:nvPr/>
        </p:nvPicPr>
        <p:blipFill>
          <a:blip r:embed="rId9"/>
          <a:srcRect l="42877" t="42191" r="42071" b="34132"/>
          <a:stretch/>
        </p:blipFill>
        <p:spPr>
          <a:xfrm>
            <a:off x="763560" y="2514600"/>
            <a:ext cx="984240" cy="1239840"/>
          </a:xfrm>
          <a:prstGeom prst="rect">
            <a:avLst/>
          </a:prstGeom>
          <a:ln w="0">
            <a:noFill/>
          </a:ln>
        </p:spPr>
      </p:pic>
      <p:sp>
        <p:nvSpPr>
          <p:cNvPr id="58" name="Text Box 19"/>
          <p:cNvSpPr/>
          <p:nvPr/>
        </p:nvSpPr>
        <p:spPr>
          <a:xfrm>
            <a:off x="862560" y="3778200"/>
            <a:ext cx="77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67G&gt;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20" descr=""/>
          <p:cNvPicPr/>
          <p:nvPr/>
        </p:nvPicPr>
        <p:blipFill>
          <a:blip r:embed="rId10"/>
          <a:srcRect l="42869" t="42600" r="41835" b="34147"/>
          <a:stretch/>
        </p:blipFill>
        <p:spPr>
          <a:xfrm>
            <a:off x="4695840" y="4948200"/>
            <a:ext cx="981000" cy="1193760"/>
          </a:xfrm>
          <a:prstGeom prst="rect">
            <a:avLst/>
          </a:prstGeom>
          <a:ln w="0">
            <a:noFill/>
          </a:ln>
        </p:spPr>
      </p:pic>
      <p:sp>
        <p:nvSpPr>
          <p:cNvPr id="60" name="Text Box 21"/>
          <p:cNvSpPr/>
          <p:nvPr/>
        </p:nvSpPr>
        <p:spPr>
          <a:xfrm>
            <a:off x="4809600" y="6165720"/>
            <a:ext cx="76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36C&gt;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22"/>
          <p:cNvSpPr/>
          <p:nvPr/>
        </p:nvSpPr>
        <p:spPr>
          <a:xfrm>
            <a:off x="228600" y="271440"/>
            <a:ext cx="45244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ure S1. Sequence traces and location of novel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TERC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mutations.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rrows indicate the heterozygous base change named beneath each panel. Their location is shown on a sketch of the TERC molecul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" name=""/>
          <p:cNvGrpSpPr/>
          <p:nvPr/>
        </p:nvGrpSpPr>
        <p:grpSpPr>
          <a:xfrm>
            <a:off x="3076560" y="750960"/>
            <a:ext cx="3595320" cy="4374000"/>
            <a:chOff x="3076560" y="750960"/>
            <a:chExt cx="3595320" cy="4374000"/>
          </a:xfrm>
        </p:grpSpPr>
        <p:grpSp>
          <p:nvGrpSpPr>
            <p:cNvPr id="63" name=""/>
            <p:cNvGrpSpPr/>
            <p:nvPr/>
          </p:nvGrpSpPr>
          <p:grpSpPr>
            <a:xfrm>
              <a:off x="4540680" y="3787560"/>
              <a:ext cx="1511640" cy="120600"/>
              <a:chOff x="4540680" y="3787560"/>
              <a:chExt cx="1511640" cy="120600"/>
            </a:xfrm>
          </p:grpSpPr>
          <p:sp>
            <p:nvSpPr>
              <p:cNvPr id="64" name=""/>
              <p:cNvSpPr/>
              <p:nvPr/>
            </p:nvSpPr>
            <p:spPr>
              <a:xfrm>
                <a:off x="454068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459072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464112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474228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479268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484308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50450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51458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51962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52466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39820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544860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554940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55994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6498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575100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580140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85180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600336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489240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46904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509832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570204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590112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6052320" y="3787560"/>
                <a:ext cx="0" cy="120600"/>
              </a:xfrm>
              <a:prstGeom prst="line">
                <a:avLst/>
              </a:prstGeom>
              <a:ln w="6480">
                <a:solidFill>
                  <a:srgbClr val="dddddd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9" name=""/>
            <p:cNvGrpSpPr/>
            <p:nvPr/>
          </p:nvGrpSpPr>
          <p:grpSpPr>
            <a:xfrm>
              <a:off x="3076560" y="3486240"/>
              <a:ext cx="2166840" cy="900720"/>
              <a:chOff x="3076560" y="3486240"/>
              <a:chExt cx="2166840" cy="900720"/>
            </a:xfrm>
          </p:grpSpPr>
          <p:grpSp>
            <p:nvGrpSpPr>
              <p:cNvPr id="90" name=""/>
              <p:cNvGrpSpPr/>
              <p:nvPr/>
            </p:nvGrpSpPr>
            <p:grpSpPr>
              <a:xfrm>
                <a:off x="3936600" y="3968280"/>
                <a:ext cx="93960" cy="129960"/>
                <a:chOff x="3936600" y="3968280"/>
                <a:chExt cx="93960" cy="129960"/>
              </a:xfrm>
            </p:grpSpPr>
            <p:sp>
              <p:nvSpPr>
                <p:cNvPr id="91" name=""/>
                <p:cNvSpPr/>
                <p:nvPr/>
              </p:nvSpPr>
              <p:spPr>
                <a:xfrm flipH="1" flipV="1">
                  <a:off x="3936600" y="3967920"/>
                  <a:ext cx="93600" cy="1299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 flipV="1">
                  <a:off x="3936960" y="3967920"/>
                  <a:ext cx="93600" cy="1299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3" name=""/>
              <p:cNvSpPr/>
              <p:nvPr/>
            </p:nvSpPr>
            <p:spPr>
              <a:xfrm>
                <a:off x="3681360" y="3912840"/>
                <a:ext cx="1209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4547880" y="3782160"/>
                <a:ext cx="695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5" name=""/>
              <p:cNvGrpSpPr/>
              <p:nvPr/>
            </p:nvGrpSpPr>
            <p:grpSpPr>
              <a:xfrm>
                <a:off x="3485160" y="3832560"/>
                <a:ext cx="189000" cy="150120"/>
                <a:chOff x="3485160" y="3832560"/>
                <a:chExt cx="189000" cy="150120"/>
              </a:xfrm>
            </p:grpSpPr>
            <p:sp>
              <p:nvSpPr>
                <p:cNvPr id="96" name=""/>
                <p:cNvSpPr/>
                <p:nvPr/>
              </p:nvSpPr>
              <p:spPr>
                <a:xfrm>
                  <a:off x="3485520" y="3832560"/>
                  <a:ext cx="18864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 flipH="1">
                  <a:off x="3485160" y="3832560"/>
                  <a:ext cx="18864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8" name=""/>
              <p:cNvGrpSpPr/>
              <p:nvPr/>
            </p:nvGrpSpPr>
            <p:grpSpPr>
              <a:xfrm>
                <a:off x="3485160" y="3953160"/>
                <a:ext cx="199440" cy="160200"/>
                <a:chOff x="3485160" y="3953160"/>
                <a:chExt cx="199440" cy="160200"/>
              </a:xfrm>
            </p:grpSpPr>
            <p:sp>
              <p:nvSpPr>
                <p:cNvPr id="99" name=""/>
                <p:cNvSpPr/>
                <p:nvPr/>
              </p:nvSpPr>
              <p:spPr>
                <a:xfrm flipH="1" flipV="1">
                  <a:off x="3485160" y="3952800"/>
                  <a:ext cx="199440" cy="16020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 flipV="1">
                  <a:off x="3485880" y="3952800"/>
                  <a:ext cx="198720" cy="16020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01" name=""/>
              <p:cNvSpPr/>
              <p:nvPr/>
            </p:nvSpPr>
            <p:spPr>
              <a:xfrm>
                <a:off x="3681360" y="4033800"/>
                <a:ext cx="2487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4033800" y="4038840"/>
                <a:ext cx="4525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3080160" y="4038840"/>
                <a:ext cx="392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3478680" y="3912840"/>
                <a:ext cx="0" cy="120600"/>
              </a:xfrm>
              <a:prstGeom prst="line">
                <a:avLst/>
              </a:prstGeom>
              <a:ln w="6480">
                <a:solidFill>
                  <a:srgbClr val="99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681360" y="3912840"/>
                <a:ext cx="0" cy="120600"/>
              </a:xfrm>
              <a:prstGeom prst="line">
                <a:avLst/>
              </a:prstGeom>
              <a:ln w="6480">
                <a:solidFill>
                  <a:srgbClr val="99cc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3080160" y="3908160"/>
                <a:ext cx="3924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7" name=""/>
              <p:cNvGrpSpPr/>
              <p:nvPr/>
            </p:nvGrpSpPr>
            <p:grpSpPr>
              <a:xfrm>
                <a:off x="3076560" y="3912840"/>
                <a:ext cx="1407240" cy="120600"/>
                <a:chOff x="3076560" y="3912840"/>
                <a:chExt cx="1407240" cy="120600"/>
              </a:xfrm>
            </p:grpSpPr>
            <p:sp>
              <p:nvSpPr>
                <p:cNvPr id="108" name=""/>
                <p:cNvSpPr/>
                <p:nvPr/>
              </p:nvSpPr>
              <p:spPr>
                <a:xfrm>
                  <a:off x="312552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317592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322596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332712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337716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342756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372960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378000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383040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393084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403200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413244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418284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433404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438444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443448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307656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387936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407808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428508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4483800" y="391284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29" name=""/>
              <p:cNvSpPr/>
              <p:nvPr/>
            </p:nvSpPr>
            <p:spPr>
              <a:xfrm>
                <a:off x="5047560" y="3912840"/>
                <a:ext cx="190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 flipV="1">
                <a:off x="4109400" y="3807720"/>
                <a:ext cx="779040" cy="2286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400000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400000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 flipV="1">
                <a:off x="4567320" y="3485880"/>
                <a:ext cx="484560" cy="87228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400000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400000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3746880" y="4360680"/>
                <a:ext cx="47412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4221000" y="4326840"/>
                <a:ext cx="577080" cy="601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13320" bIns="133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3076560" y="4043880"/>
                <a:ext cx="0" cy="31140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custDash>
                  <a:ds d="1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3085200" y="4360680"/>
                <a:ext cx="664920" cy="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custDash>
                  <a:ds d="1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3240000" y="3691800"/>
                <a:ext cx="12034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3076560" y="3691800"/>
                <a:ext cx="0" cy="20124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custDash>
                  <a:ds d="1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3098880" y="3691800"/>
                <a:ext cx="144360" cy="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custDash>
                  <a:ds d="100000" sp="1000"/>
                </a:custDash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4449960" y="3696840"/>
                <a:ext cx="86400" cy="85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520" bIns="385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0" name=""/>
            <p:cNvGrpSpPr/>
            <p:nvPr/>
          </p:nvGrpSpPr>
          <p:grpSpPr>
            <a:xfrm>
              <a:off x="5244840" y="750960"/>
              <a:ext cx="1427040" cy="4374000"/>
              <a:chOff x="5244840" y="750960"/>
              <a:chExt cx="1427040" cy="4374000"/>
            </a:xfrm>
          </p:grpSpPr>
          <p:sp>
            <p:nvSpPr>
              <p:cNvPr id="141" name=""/>
              <p:cNvSpPr/>
              <p:nvPr/>
            </p:nvSpPr>
            <p:spPr>
              <a:xfrm>
                <a:off x="6052320" y="3782520"/>
                <a:ext cx="118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 flipH="1" flipV="1">
                <a:off x="6095160" y="4998960"/>
                <a:ext cx="457200" cy="12564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842191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842191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3" name=""/>
              <p:cNvGrpSpPr/>
              <p:nvPr/>
            </p:nvGrpSpPr>
            <p:grpSpPr>
              <a:xfrm>
                <a:off x="6145200" y="4808880"/>
                <a:ext cx="357840" cy="311040"/>
                <a:chOff x="6145200" y="4808880"/>
                <a:chExt cx="357840" cy="311040"/>
              </a:xfrm>
            </p:grpSpPr>
            <p:sp>
              <p:nvSpPr>
                <p:cNvPr id="144" name=""/>
                <p:cNvSpPr/>
                <p:nvPr/>
              </p:nvSpPr>
              <p:spPr>
                <a:xfrm>
                  <a:off x="6145200" y="4808880"/>
                  <a:ext cx="357840" cy="310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 flipV="1">
                  <a:off x="6145200" y="4808880"/>
                  <a:ext cx="357840" cy="31104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6" name=""/>
              <p:cNvSpPr/>
              <p:nvPr/>
            </p:nvSpPr>
            <p:spPr>
              <a:xfrm flipH="1">
                <a:off x="6089760" y="4803840"/>
                <a:ext cx="172800" cy="24084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400000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400000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7" name=""/>
              <p:cNvGrpSpPr/>
              <p:nvPr/>
            </p:nvGrpSpPr>
            <p:grpSpPr>
              <a:xfrm>
                <a:off x="6107400" y="1221120"/>
                <a:ext cx="127440" cy="140760"/>
                <a:chOff x="6107400" y="1221120"/>
                <a:chExt cx="127440" cy="140760"/>
              </a:xfrm>
            </p:grpSpPr>
            <p:sp>
              <p:nvSpPr>
                <p:cNvPr id="148" name=""/>
                <p:cNvSpPr/>
                <p:nvPr/>
              </p:nvSpPr>
              <p:spPr>
                <a:xfrm flipH="1" flipV="1">
                  <a:off x="6107400" y="1221840"/>
                  <a:ext cx="12744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 flipH="1">
                  <a:off x="6107400" y="1221120"/>
                  <a:ext cx="127440" cy="1407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0" name=""/>
              <p:cNvGrpSpPr/>
              <p:nvPr/>
            </p:nvGrpSpPr>
            <p:grpSpPr>
              <a:xfrm>
                <a:off x="6259320" y="1221120"/>
                <a:ext cx="129600" cy="140040"/>
                <a:chOff x="6259320" y="1221120"/>
                <a:chExt cx="129600" cy="140040"/>
              </a:xfrm>
            </p:grpSpPr>
            <p:sp>
              <p:nvSpPr>
                <p:cNvPr id="151" name=""/>
                <p:cNvSpPr/>
                <p:nvPr/>
              </p:nvSpPr>
              <p:spPr>
                <a:xfrm>
                  <a:off x="6259320" y="1221120"/>
                  <a:ext cx="12960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 flipV="1">
                  <a:off x="6259320" y="1221480"/>
                  <a:ext cx="12960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3" name=""/>
              <p:cNvGrpSpPr/>
              <p:nvPr/>
            </p:nvGrpSpPr>
            <p:grpSpPr>
              <a:xfrm>
                <a:off x="6041160" y="1734840"/>
                <a:ext cx="259920" cy="366120"/>
                <a:chOff x="6041160" y="1734840"/>
                <a:chExt cx="259920" cy="366120"/>
              </a:xfrm>
            </p:grpSpPr>
            <p:sp>
              <p:nvSpPr>
                <p:cNvPr id="154" name=""/>
                <p:cNvSpPr/>
                <p:nvPr/>
              </p:nvSpPr>
              <p:spPr>
                <a:xfrm flipH="1" flipV="1">
                  <a:off x="6041160" y="1734840"/>
                  <a:ext cx="259920" cy="36540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 flipH="1">
                  <a:off x="6041160" y="1734840"/>
                  <a:ext cx="259920" cy="366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6" name=""/>
              <p:cNvSpPr/>
              <p:nvPr/>
            </p:nvSpPr>
            <p:spPr>
              <a:xfrm>
                <a:off x="6096600" y="1735920"/>
                <a:ext cx="444600" cy="36684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1370956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1370956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 flipV="1">
                <a:off x="6085800" y="1734480"/>
                <a:ext cx="466560" cy="36612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7229691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7229691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8" name=""/>
              <p:cNvGrpSpPr/>
              <p:nvPr/>
            </p:nvGrpSpPr>
            <p:grpSpPr>
              <a:xfrm>
                <a:off x="6107400" y="2292840"/>
                <a:ext cx="127440" cy="140760"/>
                <a:chOff x="6107400" y="2292840"/>
                <a:chExt cx="127440" cy="140760"/>
              </a:xfrm>
            </p:grpSpPr>
            <p:sp>
              <p:nvSpPr>
                <p:cNvPr id="159" name=""/>
                <p:cNvSpPr/>
                <p:nvPr/>
              </p:nvSpPr>
              <p:spPr>
                <a:xfrm flipH="1" flipV="1">
                  <a:off x="6107400" y="2293560"/>
                  <a:ext cx="12744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 flipH="1">
                  <a:off x="6107400" y="2292840"/>
                  <a:ext cx="127440" cy="1407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1" name=""/>
              <p:cNvGrpSpPr/>
              <p:nvPr/>
            </p:nvGrpSpPr>
            <p:grpSpPr>
              <a:xfrm>
                <a:off x="6259320" y="2292840"/>
                <a:ext cx="129600" cy="140040"/>
                <a:chOff x="6259320" y="2292840"/>
                <a:chExt cx="129600" cy="140040"/>
              </a:xfrm>
            </p:grpSpPr>
            <p:sp>
              <p:nvSpPr>
                <p:cNvPr id="162" name=""/>
                <p:cNvSpPr/>
                <p:nvPr/>
              </p:nvSpPr>
              <p:spPr>
                <a:xfrm>
                  <a:off x="6259320" y="2292840"/>
                  <a:ext cx="12960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 flipV="1">
                  <a:off x="6259320" y="2293200"/>
                  <a:ext cx="12960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4" name=""/>
              <p:cNvGrpSpPr/>
              <p:nvPr/>
            </p:nvGrpSpPr>
            <p:grpSpPr>
              <a:xfrm>
                <a:off x="6107400" y="2710440"/>
                <a:ext cx="127440" cy="140760"/>
                <a:chOff x="6107400" y="2710440"/>
                <a:chExt cx="127440" cy="140760"/>
              </a:xfrm>
            </p:grpSpPr>
            <p:sp>
              <p:nvSpPr>
                <p:cNvPr id="165" name=""/>
                <p:cNvSpPr/>
                <p:nvPr/>
              </p:nvSpPr>
              <p:spPr>
                <a:xfrm flipH="1" flipV="1">
                  <a:off x="6107400" y="2711160"/>
                  <a:ext cx="12744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 flipH="1">
                  <a:off x="6107400" y="2710440"/>
                  <a:ext cx="127440" cy="1407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67" name=""/>
              <p:cNvGrpSpPr/>
              <p:nvPr/>
            </p:nvGrpSpPr>
            <p:grpSpPr>
              <a:xfrm>
                <a:off x="6259320" y="2710440"/>
                <a:ext cx="129600" cy="140040"/>
                <a:chOff x="6259320" y="2710440"/>
                <a:chExt cx="129600" cy="140040"/>
              </a:xfrm>
            </p:grpSpPr>
            <p:sp>
              <p:nvSpPr>
                <p:cNvPr id="168" name=""/>
                <p:cNvSpPr/>
                <p:nvPr/>
              </p:nvSpPr>
              <p:spPr>
                <a:xfrm>
                  <a:off x="6259320" y="2710440"/>
                  <a:ext cx="12960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 flipV="1">
                  <a:off x="6259320" y="2710800"/>
                  <a:ext cx="12960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0" name=""/>
              <p:cNvGrpSpPr/>
              <p:nvPr/>
            </p:nvGrpSpPr>
            <p:grpSpPr>
              <a:xfrm>
                <a:off x="6041160" y="3178800"/>
                <a:ext cx="259920" cy="271080"/>
                <a:chOff x="6041160" y="3178800"/>
                <a:chExt cx="259920" cy="271080"/>
              </a:xfrm>
            </p:grpSpPr>
            <p:sp>
              <p:nvSpPr>
                <p:cNvPr id="171" name=""/>
                <p:cNvSpPr/>
                <p:nvPr/>
              </p:nvSpPr>
              <p:spPr>
                <a:xfrm flipH="1" flipV="1">
                  <a:off x="6041160" y="3178440"/>
                  <a:ext cx="259920" cy="2703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 flipH="1">
                  <a:off x="6041160" y="3178800"/>
                  <a:ext cx="259920" cy="2710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3" name=""/>
              <p:cNvGrpSpPr/>
              <p:nvPr/>
            </p:nvGrpSpPr>
            <p:grpSpPr>
              <a:xfrm>
                <a:off x="6118200" y="3183480"/>
                <a:ext cx="390960" cy="266400"/>
                <a:chOff x="6118200" y="3183480"/>
                <a:chExt cx="390960" cy="266400"/>
              </a:xfrm>
            </p:grpSpPr>
            <p:sp>
              <p:nvSpPr>
                <p:cNvPr id="174" name=""/>
                <p:cNvSpPr/>
                <p:nvPr/>
              </p:nvSpPr>
              <p:spPr>
                <a:xfrm>
                  <a:off x="6118200" y="3183840"/>
                  <a:ext cx="390960" cy="26604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"/>
                <p:cNvSpPr/>
                <p:nvPr/>
              </p:nvSpPr>
              <p:spPr>
                <a:xfrm flipV="1">
                  <a:off x="6118200" y="3183120"/>
                  <a:ext cx="390960" cy="26604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6" name=""/>
              <p:cNvGrpSpPr/>
              <p:nvPr/>
            </p:nvGrpSpPr>
            <p:grpSpPr>
              <a:xfrm>
                <a:off x="5244840" y="3706920"/>
                <a:ext cx="146520" cy="139680"/>
                <a:chOff x="5244840" y="3706920"/>
                <a:chExt cx="146520" cy="139680"/>
              </a:xfrm>
            </p:grpSpPr>
            <p:sp>
              <p:nvSpPr>
                <p:cNvPr id="177" name=""/>
                <p:cNvSpPr/>
                <p:nvPr/>
              </p:nvSpPr>
              <p:spPr>
                <a:xfrm>
                  <a:off x="5245200" y="3706920"/>
                  <a:ext cx="14616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"/>
                <p:cNvSpPr/>
                <p:nvPr/>
              </p:nvSpPr>
              <p:spPr>
                <a:xfrm flipH="1">
                  <a:off x="5244840" y="3706920"/>
                  <a:ext cx="146160" cy="1396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79" name=""/>
              <p:cNvGrpSpPr/>
              <p:nvPr/>
            </p:nvGrpSpPr>
            <p:grpSpPr>
              <a:xfrm>
                <a:off x="5244840" y="3832920"/>
                <a:ext cx="156240" cy="150120"/>
                <a:chOff x="5244840" y="3832920"/>
                <a:chExt cx="156240" cy="150120"/>
              </a:xfrm>
            </p:grpSpPr>
            <p:sp>
              <p:nvSpPr>
                <p:cNvPr id="180" name=""/>
                <p:cNvSpPr/>
                <p:nvPr/>
              </p:nvSpPr>
              <p:spPr>
                <a:xfrm flipH="1" flipV="1">
                  <a:off x="5244840" y="3832560"/>
                  <a:ext cx="15624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"/>
                <p:cNvSpPr/>
                <p:nvPr/>
              </p:nvSpPr>
              <p:spPr>
                <a:xfrm flipV="1">
                  <a:off x="5245560" y="3832560"/>
                  <a:ext cx="15552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2" name=""/>
              <p:cNvGrpSpPr/>
              <p:nvPr/>
            </p:nvGrpSpPr>
            <p:grpSpPr>
              <a:xfrm>
                <a:off x="6107400" y="4436640"/>
                <a:ext cx="127440" cy="181080"/>
                <a:chOff x="6107400" y="4436640"/>
                <a:chExt cx="127440" cy="181080"/>
              </a:xfrm>
            </p:grpSpPr>
            <p:sp>
              <p:nvSpPr>
                <p:cNvPr id="183" name=""/>
                <p:cNvSpPr/>
                <p:nvPr/>
              </p:nvSpPr>
              <p:spPr>
                <a:xfrm flipH="1" flipV="1">
                  <a:off x="6107400" y="4436280"/>
                  <a:ext cx="127440" cy="1803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"/>
                <p:cNvSpPr/>
                <p:nvPr/>
              </p:nvSpPr>
              <p:spPr>
                <a:xfrm flipH="1">
                  <a:off x="6107400" y="4436640"/>
                  <a:ext cx="127440" cy="18108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5" name=""/>
              <p:cNvGrpSpPr/>
              <p:nvPr/>
            </p:nvGrpSpPr>
            <p:grpSpPr>
              <a:xfrm>
                <a:off x="6260400" y="4436280"/>
                <a:ext cx="127440" cy="180720"/>
                <a:chOff x="6260400" y="4436280"/>
                <a:chExt cx="127440" cy="180720"/>
              </a:xfrm>
            </p:grpSpPr>
            <p:sp>
              <p:nvSpPr>
                <p:cNvPr id="186" name=""/>
                <p:cNvSpPr/>
                <p:nvPr/>
              </p:nvSpPr>
              <p:spPr>
                <a:xfrm>
                  <a:off x="6260400" y="4436640"/>
                  <a:ext cx="127440" cy="1803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"/>
                <p:cNvSpPr/>
                <p:nvPr/>
              </p:nvSpPr>
              <p:spPr>
                <a:xfrm flipV="1">
                  <a:off x="6260400" y="4435920"/>
                  <a:ext cx="127440" cy="1803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88" name=""/>
              <p:cNvGrpSpPr/>
              <p:nvPr/>
            </p:nvGrpSpPr>
            <p:grpSpPr>
              <a:xfrm>
                <a:off x="5774400" y="4844160"/>
                <a:ext cx="156600" cy="150120"/>
                <a:chOff x="5774400" y="4844160"/>
                <a:chExt cx="156600" cy="150120"/>
              </a:xfrm>
            </p:grpSpPr>
            <p:sp>
              <p:nvSpPr>
                <p:cNvPr id="189" name=""/>
                <p:cNvSpPr/>
                <p:nvPr/>
              </p:nvSpPr>
              <p:spPr>
                <a:xfrm>
                  <a:off x="5774760" y="4844160"/>
                  <a:ext cx="15624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"/>
                <p:cNvSpPr/>
                <p:nvPr/>
              </p:nvSpPr>
              <p:spPr>
                <a:xfrm flipH="1">
                  <a:off x="5774400" y="4844160"/>
                  <a:ext cx="15624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1" name=""/>
              <p:cNvGrpSpPr/>
              <p:nvPr/>
            </p:nvGrpSpPr>
            <p:grpSpPr>
              <a:xfrm>
                <a:off x="5779080" y="4969800"/>
                <a:ext cx="155520" cy="150120"/>
                <a:chOff x="5779080" y="4969800"/>
                <a:chExt cx="155520" cy="150120"/>
              </a:xfrm>
            </p:grpSpPr>
            <p:sp>
              <p:nvSpPr>
                <p:cNvPr id="192" name=""/>
                <p:cNvSpPr/>
                <p:nvPr/>
              </p:nvSpPr>
              <p:spPr>
                <a:xfrm flipH="1" flipV="1">
                  <a:off x="5779080" y="4969440"/>
                  <a:ext cx="15552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"/>
                <p:cNvSpPr/>
                <p:nvPr/>
              </p:nvSpPr>
              <p:spPr>
                <a:xfrm flipV="1">
                  <a:off x="5779800" y="4969440"/>
                  <a:ext cx="154800" cy="1501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4" name=""/>
              <p:cNvGrpSpPr/>
              <p:nvPr/>
            </p:nvGrpSpPr>
            <p:grpSpPr>
              <a:xfrm>
                <a:off x="5415840" y="4854240"/>
                <a:ext cx="257760" cy="250920"/>
                <a:chOff x="5415840" y="4854240"/>
                <a:chExt cx="257760" cy="250920"/>
              </a:xfrm>
            </p:grpSpPr>
            <p:sp>
              <p:nvSpPr>
                <p:cNvPr id="195" name=""/>
                <p:cNvSpPr/>
                <p:nvPr/>
              </p:nvSpPr>
              <p:spPr>
                <a:xfrm flipH="1" flipV="1">
                  <a:off x="5415840" y="4853880"/>
                  <a:ext cx="257760" cy="25020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"/>
                <p:cNvSpPr/>
                <p:nvPr/>
              </p:nvSpPr>
              <p:spPr>
                <a:xfrm flipH="1">
                  <a:off x="5415840" y="4854240"/>
                  <a:ext cx="257760" cy="25092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97" name=""/>
              <p:cNvSpPr/>
              <p:nvPr/>
            </p:nvSpPr>
            <p:spPr>
              <a:xfrm>
                <a:off x="6122520" y="4074480"/>
                <a:ext cx="64080" cy="1454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6307560" y="3867840"/>
                <a:ext cx="64080" cy="34200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6319080" y="3782520"/>
                <a:ext cx="32760" cy="80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480" bIns="33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 flipH="1">
                <a:off x="6318720" y="4210200"/>
                <a:ext cx="21240" cy="853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520" bIns="385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6150240" y="4220280"/>
                <a:ext cx="37440" cy="75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6150240" y="4024080"/>
                <a:ext cx="0" cy="4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" bIns="-1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5401800" y="3782520"/>
                <a:ext cx="6375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5406840" y="3908520"/>
                <a:ext cx="6375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5730120" y="4311000"/>
                <a:ext cx="31464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5941440" y="4920840"/>
                <a:ext cx="1468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941440" y="5051880"/>
                <a:ext cx="1443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5619600" y="4915800"/>
                <a:ext cx="1422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5619600" y="5046480"/>
                <a:ext cx="1468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0" name=""/>
              <p:cNvGrpSpPr/>
              <p:nvPr/>
            </p:nvGrpSpPr>
            <p:grpSpPr>
              <a:xfrm>
                <a:off x="5621040" y="4919760"/>
                <a:ext cx="468720" cy="120600"/>
                <a:chOff x="5621040" y="4919760"/>
                <a:chExt cx="468720" cy="120600"/>
              </a:xfrm>
            </p:grpSpPr>
            <p:sp>
              <p:nvSpPr>
                <p:cNvPr id="211" name=""/>
                <p:cNvSpPr/>
                <p:nvPr/>
              </p:nvSpPr>
              <p:spPr>
                <a:xfrm>
                  <a:off x="593784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"/>
                <p:cNvSpPr/>
                <p:nvPr/>
              </p:nvSpPr>
              <p:spPr>
                <a:xfrm>
                  <a:off x="603900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"/>
                <p:cNvSpPr/>
                <p:nvPr/>
              </p:nvSpPr>
              <p:spPr>
                <a:xfrm>
                  <a:off x="608976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"/>
                <p:cNvSpPr/>
                <p:nvPr/>
              </p:nvSpPr>
              <p:spPr>
                <a:xfrm>
                  <a:off x="562104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"/>
                <p:cNvSpPr/>
                <p:nvPr/>
              </p:nvSpPr>
              <p:spPr>
                <a:xfrm>
                  <a:off x="572220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"/>
                <p:cNvSpPr/>
                <p:nvPr/>
              </p:nvSpPr>
              <p:spPr>
                <a:xfrm>
                  <a:off x="577260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"/>
                <p:cNvSpPr/>
                <p:nvPr/>
              </p:nvSpPr>
              <p:spPr>
                <a:xfrm>
                  <a:off x="597888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"/>
                <p:cNvSpPr/>
                <p:nvPr/>
              </p:nvSpPr>
              <p:spPr>
                <a:xfrm>
                  <a:off x="5667480" y="4919760"/>
                  <a:ext cx="0" cy="1206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19" name=""/>
              <p:cNvGrpSpPr/>
              <p:nvPr/>
            </p:nvGrpSpPr>
            <p:grpSpPr>
              <a:xfrm>
                <a:off x="6175440" y="1362240"/>
                <a:ext cx="130680" cy="372240"/>
                <a:chOff x="6175440" y="1362240"/>
                <a:chExt cx="130680" cy="372240"/>
              </a:xfrm>
            </p:grpSpPr>
            <p:sp>
              <p:nvSpPr>
                <p:cNvPr id="220" name=""/>
                <p:cNvSpPr/>
                <p:nvPr/>
              </p:nvSpPr>
              <p:spPr>
                <a:xfrm>
                  <a:off x="6175440" y="13622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"/>
                <p:cNvSpPr/>
                <p:nvPr/>
              </p:nvSpPr>
              <p:spPr>
                <a:xfrm>
                  <a:off x="6175440" y="14086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"/>
                <p:cNvSpPr/>
                <p:nvPr/>
              </p:nvSpPr>
              <p:spPr>
                <a:xfrm>
                  <a:off x="6175440" y="15483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"/>
                <p:cNvSpPr/>
                <p:nvPr/>
              </p:nvSpPr>
              <p:spPr>
                <a:xfrm>
                  <a:off x="6175440" y="159480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"/>
                <p:cNvSpPr/>
                <p:nvPr/>
              </p:nvSpPr>
              <p:spPr>
                <a:xfrm>
                  <a:off x="6175440" y="16876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"/>
                <p:cNvSpPr/>
                <p:nvPr/>
              </p:nvSpPr>
              <p:spPr>
                <a:xfrm>
                  <a:off x="6175440" y="17344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"/>
                <p:cNvSpPr/>
                <p:nvPr/>
              </p:nvSpPr>
              <p:spPr>
                <a:xfrm>
                  <a:off x="6175440" y="14536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"/>
                <p:cNvSpPr/>
                <p:nvPr/>
              </p:nvSpPr>
              <p:spPr>
                <a:xfrm>
                  <a:off x="6175440" y="16401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28" name=""/>
              <p:cNvGrpSpPr/>
              <p:nvPr/>
            </p:nvGrpSpPr>
            <p:grpSpPr>
              <a:xfrm>
                <a:off x="6175440" y="2107080"/>
                <a:ext cx="130680" cy="185760"/>
                <a:chOff x="6175440" y="2107080"/>
                <a:chExt cx="130680" cy="185760"/>
              </a:xfrm>
            </p:grpSpPr>
            <p:sp>
              <p:nvSpPr>
                <p:cNvPr id="229" name=""/>
                <p:cNvSpPr/>
                <p:nvPr/>
              </p:nvSpPr>
              <p:spPr>
                <a:xfrm>
                  <a:off x="6175440" y="21070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"/>
                <p:cNvSpPr/>
                <p:nvPr/>
              </p:nvSpPr>
              <p:spPr>
                <a:xfrm>
                  <a:off x="6175440" y="21531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"/>
                <p:cNvSpPr/>
                <p:nvPr/>
              </p:nvSpPr>
              <p:spPr>
                <a:xfrm>
                  <a:off x="6175440" y="22460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"/>
                <p:cNvSpPr/>
                <p:nvPr/>
              </p:nvSpPr>
              <p:spPr>
                <a:xfrm>
                  <a:off x="6175440" y="22928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"/>
                <p:cNvSpPr/>
                <p:nvPr/>
              </p:nvSpPr>
              <p:spPr>
                <a:xfrm>
                  <a:off x="6175440" y="220320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34" name=""/>
              <p:cNvGrpSpPr/>
              <p:nvPr/>
            </p:nvGrpSpPr>
            <p:grpSpPr>
              <a:xfrm>
                <a:off x="6175440" y="2432880"/>
                <a:ext cx="130680" cy="279000"/>
                <a:chOff x="6175440" y="2432880"/>
                <a:chExt cx="130680" cy="279000"/>
              </a:xfrm>
            </p:grpSpPr>
            <p:sp>
              <p:nvSpPr>
                <p:cNvPr id="235" name=""/>
                <p:cNvSpPr/>
                <p:nvPr/>
              </p:nvSpPr>
              <p:spPr>
                <a:xfrm>
                  <a:off x="6175440" y="24328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"/>
                <p:cNvSpPr/>
                <p:nvPr/>
              </p:nvSpPr>
              <p:spPr>
                <a:xfrm>
                  <a:off x="6175440" y="247932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"/>
                <p:cNvSpPr/>
                <p:nvPr/>
              </p:nvSpPr>
              <p:spPr>
                <a:xfrm>
                  <a:off x="6175440" y="25257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"/>
                <p:cNvSpPr/>
                <p:nvPr/>
              </p:nvSpPr>
              <p:spPr>
                <a:xfrm>
                  <a:off x="6175440" y="261900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"/>
                <p:cNvSpPr/>
                <p:nvPr/>
              </p:nvSpPr>
              <p:spPr>
                <a:xfrm>
                  <a:off x="6175440" y="26654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6175440" y="27118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"/>
                <p:cNvSpPr/>
                <p:nvPr/>
              </p:nvSpPr>
              <p:spPr>
                <a:xfrm>
                  <a:off x="6175440" y="257112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42" name=""/>
              <p:cNvGrpSpPr/>
              <p:nvPr/>
            </p:nvGrpSpPr>
            <p:grpSpPr>
              <a:xfrm>
                <a:off x="6175440" y="2851560"/>
                <a:ext cx="130680" cy="325440"/>
                <a:chOff x="6175440" y="2851560"/>
                <a:chExt cx="130680" cy="325440"/>
              </a:xfrm>
            </p:grpSpPr>
            <p:sp>
              <p:nvSpPr>
                <p:cNvPr id="243" name=""/>
                <p:cNvSpPr/>
                <p:nvPr/>
              </p:nvSpPr>
              <p:spPr>
                <a:xfrm>
                  <a:off x="6175440" y="28515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"/>
                <p:cNvSpPr/>
                <p:nvPr/>
              </p:nvSpPr>
              <p:spPr>
                <a:xfrm>
                  <a:off x="6175440" y="289800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"/>
                <p:cNvSpPr/>
                <p:nvPr/>
              </p:nvSpPr>
              <p:spPr>
                <a:xfrm>
                  <a:off x="6175440" y="29908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"/>
                <p:cNvSpPr/>
                <p:nvPr/>
              </p:nvSpPr>
              <p:spPr>
                <a:xfrm>
                  <a:off x="6175440" y="303732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"/>
                <p:cNvSpPr/>
                <p:nvPr/>
              </p:nvSpPr>
              <p:spPr>
                <a:xfrm>
                  <a:off x="6175440" y="30837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"/>
                <p:cNvSpPr/>
                <p:nvPr/>
              </p:nvSpPr>
              <p:spPr>
                <a:xfrm>
                  <a:off x="6175440" y="317700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"/>
                <p:cNvSpPr/>
                <p:nvPr/>
              </p:nvSpPr>
              <p:spPr>
                <a:xfrm>
                  <a:off x="6175440" y="29480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"/>
                <p:cNvSpPr/>
                <p:nvPr/>
              </p:nvSpPr>
              <p:spPr>
                <a:xfrm>
                  <a:off x="6175440" y="31341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51" name=""/>
              <p:cNvGrpSpPr/>
              <p:nvPr/>
            </p:nvGrpSpPr>
            <p:grpSpPr>
              <a:xfrm>
                <a:off x="6183000" y="4294440"/>
                <a:ext cx="130320" cy="510840"/>
                <a:chOff x="6183000" y="4294440"/>
                <a:chExt cx="130320" cy="510840"/>
              </a:xfrm>
            </p:grpSpPr>
            <p:sp>
              <p:nvSpPr>
                <p:cNvPr id="252" name=""/>
                <p:cNvSpPr/>
                <p:nvPr/>
              </p:nvSpPr>
              <p:spPr>
                <a:xfrm>
                  <a:off x="6183000" y="429444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"/>
                <p:cNvSpPr/>
                <p:nvPr/>
              </p:nvSpPr>
              <p:spPr>
                <a:xfrm>
                  <a:off x="6183000" y="434088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"/>
                <p:cNvSpPr/>
                <p:nvPr/>
              </p:nvSpPr>
              <p:spPr>
                <a:xfrm>
                  <a:off x="6183000" y="438768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"/>
                <p:cNvSpPr/>
                <p:nvPr/>
              </p:nvSpPr>
              <p:spPr>
                <a:xfrm>
                  <a:off x="6183000" y="466668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"/>
                <p:cNvSpPr/>
                <p:nvPr/>
              </p:nvSpPr>
              <p:spPr>
                <a:xfrm>
                  <a:off x="6183000" y="471348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"/>
                <p:cNvSpPr/>
                <p:nvPr/>
              </p:nvSpPr>
              <p:spPr>
                <a:xfrm>
                  <a:off x="6183000" y="475992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"/>
                <p:cNvSpPr/>
                <p:nvPr/>
              </p:nvSpPr>
              <p:spPr>
                <a:xfrm>
                  <a:off x="6183000" y="443268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"/>
                <p:cNvSpPr/>
                <p:nvPr/>
              </p:nvSpPr>
              <p:spPr>
                <a:xfrm>
                  <a:off x="6183000" y="461880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"/>
                <p:cNvSpPr/>
                <p:nvPr/>
              </p:nvSpPr>
              <p:spPr>
                <a:xfrm>
                  <a:off x="6183000" y="4805280"/>
                  <a:ext cx="13032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61" name=""/>
              <p:cNvSpPr/>
              <p:nvPr/>
            </p:nvSpPr>
            <p:spPr>
              <a:xfrm>
                <a:off x="6053760" y="3913200"/>
                <a:ext cx="0" cy="397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6173280" y="889200"/>
                <a:ext cx="0" cy="32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63" name=""/>
              <p:cNvGrpSpPr/>
              <p:nvPr/>
            </p:nvGrpSpPr>
            <p:grpSpPr>
              <a:xfrm>
                <a:off x="6175440" y="892800"/>
                <a:ext cx="130680" cy="329760"/>
                <a:chOff x="6175440" y="892800"/>
                <a:chExt cx="130680" cy="329760"/>
              </a:xfrm>
            </p:grpSpPr>
            <p:sp>
              <p:nvSpPr>
                <p:cNvPr id="264" name=""/>
                <p:cNvSpPr/>
                <p:nvPr/>
              </p:nvSpPr>
              <p:spPr>
                <a:xfrm>
                  <a:off x="6175440" y="9428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"/>
                <p:cNvSpPr/>
                <p:nvPr/>
              </p:nvSpPr>
              <p:spPr>
                <a:xfrm>
                  <a:off x="6175440" y="9892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"/>
                <p:cNvSpPr/>
                <p:nvPr/>
              </p:nvSpPr>
              <p:spPr>
                <a:xfrm>
                  <a:off x="6175440" y="10360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"/>
                <p:cNvSpPr/>
                <p:nvPr/>
              </p:nvSpPr>
              <p:spPr>
                <a:xfrm>
                  <a:off x="6175440" y="112932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"/>
                <p:cNvSpPr/>
                <p:nvPr/>
              </p:nvSpPr>
              <p:spPr>
                <a:xfrm>
                  <a:off x="6175440" y="11757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"/>
                <p:cNvSpPr/>
                <p:nvPr/>
              </p:nvSpPr>
              <p:spPr>
                <a:xfrm>
                  <a:off x="6175440" y="122256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"/>
                <p:cNvSpPr/>
                <p:nvPr/>
              </p:nvSpPr>
              <p:spPr>
                <a:xfrm>
                  <a:off x="6175440" y="10814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"/>
                <p:cNvSpPr/>
                <p:nvPr/>
              </p:nvSpPr>
              <p:spPr>
                <a:xfrm>
                  <a:off x="6175440" y="89280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72" name=""/>
              <p:cNvSpPr/>
              <p:nvPr/>
            </p:nvSpPr>
            <p:spPr>
              <a:xfrm>
                <a:off x="6315120" y="889200"/>
                <a:ext cx="0" cy="326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"/>
              <p:cNvSpPr/>
              <p:nvPr/>
            </p:nvSpPr>
            <p:spPr>
              <a:xfrm>
                <a:off x="6315120" y="1367280"/>
                <a:ext cx="0" cy="362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4" name=""/>
              <p:cNvSpPr/>
              <p:nvPr/>
            </p:nvSpPr>
            <p:spPr>
              <a:xfrm>
                <a:off x="6173280" y="1367280"/>
                <a:ext cx="0" cy="3621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6315120" y="2101680"/>
                <a:ext cx="0" cy="186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6" name=""/>
              <p:cNvSpPr/>
              <p:nvPr/>
            </p:nvSpPr>
            <p:spPr>
              <a:xfrm>
                <a:off x="6173280" y="2101680"/>
                <a:ext cx="0" cy="1861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7" name=""/>
              <p:cNvSpPr/>
              <p:nvPr/>
            </p:nvSpPr>
            <p:spPr>
              <a:xfrm>
                <a:off x="6315120" y="2433960"/>
                <a:ext cx="0" cy="276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8" name=""/>
              <p:cNvSpPr/>
              <p:nvPr/>
            </p:nvSpPr>
            <p:spPr>
              <a:xfrm>
                <a:off x="6173280" y="2433960"/>
                <a:ext cx="0" cy="2764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"/>
              <p:cNvSpPr/>
              <p:nvPr/>
            </p:nvSpPr>
            <p:spPr>
              <a:xfrm>
                <a:off x="6173280" y="2851560"/>
                <a:ext cx="0" cy="33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"/>
              <p:cNvSpPr/>
              <p:nvPr/>
            </p:nvSpPr>
            <p:spPr>
              <a:xfrm>
                <a:off x="6315120" y="2851560"/>
                <a:ext cx="0" cy="33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"/>
              <p:cNvSpPr/>
              <p:nvPr/>
            </p:nvSpPr>
            <p:spPr>
              <a:xfrm>
                <a:off x="6315120" y="3455280"/>
                <a:ext cx="0" cy="331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6173280" y="3450240"/>
                <a:ext cx="0" cy="3322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6315120" y="4617720"/>
                <a:ext cx="0" cy="185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"/>
              <p:cNvSpPr/>
              <p:nvPr/>
            </p:nvSpPr>
            <p:spPr>
              <a:xfrm>
                <a:off x="6173280" y="4617720"/>
                <a:ext cx="0" cy="185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"/>
              <p:cNvSpPr/>
              <p:nvPr/>
            </p:nvSpPr>
            <p:spPr>
              <a:xfrm>
                <a:off x="6320160" y="4295880"/>
                <a:ext cx="0" cy="140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"/>
              <p:cNvSpPr/>
              <p:nvPr/>
            </p:nvSpPr>
            <p:spPr>
              <a:xfrm>
                <a:off x="6184440" y="4290840"/>
                <a:ext cx="0" cy="140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87" name=""/>
              <p:cNvGrpSpPr/>
              <p:nvPr/>
            </p:nvGrpSpPr>
            <p:grpSpPr>
              <a:xfrm>
                <a:off x="6175440" y="3456720"/>
                <a:ext cx="130680" cy="324360"/>
                <a:chOff x="6175440" y="3456720"/>
                <a:chExt cx="130680" cy="324360"/>
              </a:xfrm>
            </p:grpSpPr>
            <p:sp>
              <p:nvSpPr>
                <p:cNvPr id="288" name=""/>
                <p:cNvSpPr/>
                <p:nvPr/>
              </p:nvSpPr>
              <p:spPr>
                <a:xfrm>
                  <a:off x="6175440" y="345672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"/>
                <p:cNvSpPr/>
                <p:nvPr/>
              </p:nvSpPr>
              <p:spPr>
                <a:xfrm>
                  <a:off x="6175440" y="354960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"/>
                <p:cNvSpPr/>
                <p:nvPr/>
              </p:nvSpPr>
              <p:spPr>
                <a:xfrm>
                  <a:off x="6175440" y="35960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"/>
                <p:cNvSpPr/>
                <p:nvPr/>
              </p:nvSpPr>
              <p:spPr>
                <a:xfrm>
                  <a:off x="6175440" y="36424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"/>
                <p:cNvSpPr/>
                <p:nvPr/>
              </p:nvSpPr>
              <p:spPr>
                <a:xfrm>
                  <a:off x="6175440" y="373572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"/>
                <p:cNvSpPr/>
                <p:nvPr/>
              </p:nvSpPr>
              <p:spPr>
                <a:xfrm>
                  <a:off x="6175440" y="350424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"/>
                <p:cNvSpPr/>
                <p:nvPr/>
              </p:nvSpPr>
              <p:spPr>
                <a:xfrm>
                  <a:off x="6175440" y="368532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"/>
                <p:cNvSpPr/>
                <p:nvPr/>
              </p:nvSpPr>
              <p:spPr>
                <a:xfrm>
                  <a:off x="6175440" y="3781080"/>
                  <a:ext cx="130680" cy="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96" name=""/>
              <p:cNvSpPr/>
              <p:nvPr/>
            </p:nvSpPr>
            <p:spPr>
              <a:xfrm>
                <a:off x="5487840" y="4854240"/>
                <a:ext cx="127440" cy="11772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400000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400000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97" name=""/>
              <p:cNvGrpSpPr/>
              <p:nvPr/>
            </p:nvGrpSpPr>
            <p:grpSpPr>
              <a:xfrm>
                <a:off x="6117840" y="750960"/>
                <a:ext cx="250920" cy="147960"/>
                <a:chOff x="6117840" y="750960"/>
                <a:chExt cx="250920" cy="147960"/>
              </a:xfrm>
            </p:grpSpPr>
            <p:sp>
              <p:nvSpPr>
                <p:cNvPr id="298" name=""/>
                <p:cNvSpPr/>
                <p:nvPr/>
              </p:nvSpPr>
              <p:spPr>
                <a:xfrm>
                  <a:off x="6118200" y="750960"/>
                  <a:ext cx="250560" cy="1479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"/>
                <p:cNvSpPr/>
                <p:nvPr/>
              </p:nvSpPr>
              <p:spPr>
                <a:xfrm flipH="1">
                  <a:off x="6117840" y="750960"/>
                  <a:ext cx="250560" cy="14796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00" name=""/>
              <p:cNvSpPr/>
              <p:nvPr/>
            </p:nvSpPr>
            <p:spPr>
              <a:xfrm flipV="1">
                <a:off x="6266880" y="776880"/>
                <a:ext cx="101520" cy="10476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400000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400000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 flipH="1" flipV="1">
                <a:off x="6117840" y="779040"/>
                <a:ext cx="106560" cy="10260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400000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400000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"/>
              <p:cNvSpPr/>
              <p:nvPr/>
            </p:nvSpPr>
            <p:spPr>
              <a:xfrm flipV="1">
                <a:off x="5483880" y="4985640"/>
                <a:ext cx="130320" cy="117720"/>
              </a:xfrm>
              <a:custGeom>
                <a:avLst/>
                <a:gdLst/>
                <a:ahLst/>
                <a:rect l="l" t="t" r="r" b="b"/>
                <a:pathLst>
                  <a:path stroke="0" w="21600" h="21600">
                    <a:moveTo>
                      <a:pt x="10800" y="0"/>
                    </a:moveTo>
                    <a:arcTo wR="10800" hR="10800" stAng="-5400000" swAng="5400000"/>
                    <a:lnTo>
                      <a:pt x="10800" y="10800"/>
                    </a:lnTo>
                    <a:close/>
                  </a:path>
                  <a:path fill="none" w="21600" h="21600">
                    <a:moveTo>
                      <a:pt x="10800" y="0"/>
                    </a:moveTo>
                    <a:arcTo wR="10800" hR="10800" stAng="-5400000" swAng="5400000"/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03" name=""/>
              <p:cNvGrpSpPr/>
              <p:nvPr/>
            </p:nvGrpSpPr>
            <p:grpSpPr>
              <a:xfrm>
                <a:off x="6467400" y="1512720"/>
                <a:ext cx="204480" cy="208800"/>
                <a:chOff x="6467400" y="1512720"/>
                <a:chExt cx="204480" cy="208800"/>
              </a:xfrm>
            </p:grpSpPr>
            <p:sp>
              <p:nvSpPr>
                <p:cNvPr id="304" name=""/>
                <p:cNvSpPr/>
                <p:nvPr/>
              </p:nvSpPr>
              <p:spPr>
                <a:xfrm rot="1776600">
                  <a:off x="6497280" y="1537920"/>
                  <a:ext cx="144720" cy="15804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"/>
                <p:cNvSpPr/>
                <p:nvPr/>
              </p:nvSpPr>
              <p:spPr>
                <a:xfrm flipH="1" rot="1776600">
                  <a:off x="6496560" y="1538280"/>
                  <a:ext cx="144720" cy="158040"/>
                </a:xfrm>
                <a:custGeom>
                  <a:avLst/>
                  <a:gdLst/>
                  <a:ahLst/>
                  <a:rect l="l" t="t" r="r" b="b"/>
                  <a:pathLst>
                    <a:path stroke="0" w="21600" h="21600">
                      <a:moveTo>
                        <a:pt x="10800" y="0"/>
                      </a:moveTo>
                      <a:arcTo wR="10800" hR="10800" stAng="-5400000" swAng="5400000"/>
                      <a:lnTo>
                        <a:pt x="10800" y="10800"/>
                      </a:lnTo>
                      <a:close/>
                    </a:path>
                    <a:path fill="none" w="21600" h="21600">
                      <a:moveTo>
                        <a:pt x="10800" y="0"/>
                      </a:moveTo>
                      <a:arcTo wR="10800" hR="10800" stAng="-5400000" swAng="5400000"/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06" name=""/>
              <p:cNvGrpSpPr/>
              <p:nvPr/>
            </p:nvGrpSpPr>
            <p:grpSpPr>
              <a:xfrm>
                <a:off x="6408360" y="1590840"/>
                <a:ext cx="205560" cy="226440"/>
                <a:chOff x="6408360" y="1590840"/>
                <a:chExt cx="205560" cy="226440"/>
              </a:xfrm>
            </p:grpSpPr>
            <p:sp>
              <p:nvSpPr>
                <p:cNvPr id="307" name=""/>
                <p:cNvSpPr/>
                <p:nvPr/>
              </p:nvSpPr>
              <p:spPr>
                <a:xfrm>
                  <a:off x="6500160" y="1590840"/>
                  <a:ext cx="113760" cy="648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"/>
                <p:cNvSpPr/>
                <p:nvPr/>
              </p:nvSpPr>
              <p:spPr>
                <a:xfrm>
                  <a:off x="6477120" y="1631160"/>
                  <a:ext cx="113760" cy="648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"/>
                <p:cNvSpPr/>
                <p:nvPr/>
              </p:nvSpPr>
              <p:spPr>
                <a:xfrm>
                  <a:off x="6431400" y="1712160"/>
                  <a:ext cx="113400" cy="6444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7640" bIns="176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"/>
                <p:cNvSpPr/>
                <p:nvPr/>
              </p:nvSpPr>
              <p:spPr>
                <a:xfrm>
                  <a:off x="6408360" y="1752840"/>
                  <a:ext cx="113400" cy="6444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7640" bIns="1764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"/>
                <p:cNvSpPr/>
                <p:nvPr/>
              </p:nvSpPr>
              <p:spPr>
                <a:xfrm>
                  <a:off x="6452640" y="1674720"/>
                  <a:ext cx="113400" cy="64800"/>
                </a:xfrm>
                <a:prstGeom prst="line">
                  <a:avLst/>
                </a:prstGeom>
                <a:ln w="6480">
                  <a:solidFill>
                    <a:srgbClr val="ddddd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12" name=""/>
              <p:cNvSpPr/>
              <p:nvPr/>
            </p:nvSpPr>
            <p:spPr>
              <a:xfrm flipH="1">
                <a:off x="6533280" y="1652400"/>
                <a:ext cx="92160" cy="16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 flipH="1">
                <a:off x="6408720" y="1588320"/>
                <a:ext cx="92160" cy="16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314" name="" descr=""/>
          <p:cNvPicPr/>
          <p:nvPr/>
        </p:nvPicPr>
        <p:blipFill>
          <a:blip r:embed="rId11"/>
          <a:srcRect l="48242" t="50943" r="39975" b="21743"/>
          <a:stretch/>
        </p:blipFill>
        <p:spPr>
          <a:xfrm>
            <a:off x="7243920" y="4205160"/>
            <a:ext cx="1000080" cy="1238400"/>
          </a:xfrm>
          <a:prstGeom prst="rect">
            <a:avLst/>
          </a:prstGeom>
          <a:ln w="0">
            <a:noFill/>
          </a:ln>
        </p:spPr>
      </p:pic>
      <p:sp>
        <p:nvSpPr>
          <p:cNvPr id="315" name="Text Box 17"/>
          <p:cNvSpPr/>
          <p:nvPr/>
        </p:nvSpPr>
        <p:spPr>
          <a:xfrm>
            <a:off x="7316640" y="5475240"/>
            <a:ext cx="86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c.377A&gt;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3084480" y="4378320"/>
            <a:ext cx="1441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Pseudoknot/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template doma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5978520" y="5241960"/>
            <a:ext cx="1197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ScaRN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doma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5278320" y="939960"/>
            <a:ext cx="1044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CR4-CR5 doma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rot="16200000">
            <a:off x="6234120" y="394848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H b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4183200" y="4138560"/>
            <a:ext cx="60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Templat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 flipH="1" flipV="1">
            <a:off x="6384960" y="4140000"/>
            <a:ext cx="830160" cy="52524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 flipH="1" flipV="1">
            <a:off x="6180120" y="2313000"/>
            <a:ext cx="1419120" cy="99360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 flipH="1">
            <a:off x="6341760" y="1179360"/>
            <a:ext cx="826920" cy="324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 flipH="1">
            <a:off x="4838400" y="3195720"/>
            <a:ext cx="4680" cy="56988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3762360" y="2449440"/>
            <a:ext cx="824040" cy="130644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2579760" y="2987640"/>
            <a:ext cx="1330200" cy="89532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1824120" y="3762360"/>
            <a:ext cx="1393920" cy="25092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 flipV="1">
            <a:off x="1706400" y="4064040"/>
            <a:ext cx="2194200" cy="77472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4376880" y="4083120"/>
            <a:ext cx="698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 flipV="1">
            <a:off x="2836800" y="4092480"/>
            <a:ext cx="1562040" cy="930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 flipV="1">
            <a:off x="4297320" y="3933360"/>
            <a:ext cx="587520" cy="142236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 flipV="1">
            <a:off x="5097600" y="3927240"/>
            <a:ext cx="0" cy="138420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stealth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2352600" y="188280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3659040" y="155088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5022720" y="2257560"/>
            <a:ext cx="0" cy="21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8177040" y="284004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7674120" y="1079640"/>
            <a:ext cx="0" cy="21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7761240" y="4481640"/>
            <a:ext cx="0" cy="21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5210280" y="543564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3897360" y="562752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2394000" y="4753080"/>
            <a:ext cx="0" cy="2156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1233360" y="446868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1263600" y="3003480"/>
            <a:ext cx="0" cy="216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2T12:09:57Z</dcterms:created>
  <dc:creator>tvulliamy</dc:creator>
  <dc:description/>
  <dc:language>en-US</dc:language>
  <cp:lastModifiedBy>tvulliamy</cp:lastModifiedBy>
  <dcterms:modified xsi:type="dcterms:W3CDTF">2011-04-12T12:10:39Z</dcterms:modified>
  <cp:revision>1</cp:revision>
  <dc:subject/>
  <dc:title>Slide 1</dc:title>
</cp:coreProperties>
</file>